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57" r:id="rId2"/>
    <p:sldId id="540" r:id="rId3"/>
    <p:sldId id="541" r:id="rId4"/>
    <p:sldId id="542" r:id="rId5"/>
    <p:sldId id="543" r:id="rId6"/>
    <p:sldId id="54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92" autoAdjust="0"/>
    <p:restoredTop sz="94660"/>
  </p:normalViewPr>
  <p:slideViewPr>
    <p:cSldViewPr snapToGrid="0">
      <p:cViewPr varScale="1">
        <p:scale>
          <a:sx n="49" d="100"/>
          <a:sy n="49" d="100"/>
        </p:scale>
        <p:origin x="29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o Merletti" userId="49473658533eb44f" providerId="LiveId" clId="{172C4C5D-A8F3-4134-AD16-791B771D8476}"/>
    <pc:docChg chg="custSel modSld modMainMaster">
      <pc:chgData name="Roberto Merletti" userId="49473658533eb44f" providerId="LiveId" clId="{172C4C5D-A8F3-4134-AD16-791B771D8476}" dt="2022-04-24T21:51:54.117" v="14" actId="478"/>
      <pc:docMkLst>
        <pc:docMk/>
      </pc:docMkLst>
      <pc:sldChg chg="delSp mod">
        <pc:chgData name="Roberto Merletti" userId="49473658533eb44f" providerId="LiveId" clId="{172C4C5D-A8F3-4134-AD16-791B771D8476}" dt="2022-04-24T21:51:12.405" v="3" actId="478"/>
        <pc:sldMkLst>
          <pc:docMk/>
          <pc:sldMk cId="1686707293" sldId="540"/>
        </pc:sldMkLst>
        <pc:spChg chg="del">
          <ac:chgData name="Roberto Merletti" userId="49473658533eb44f" providerId="LiveId" clId="{172C4C5D-A8F3-4134-AD16-791B771D8476}" dt="2022-04-24T21:51:09.941" v="2" actId="478"/>
          <ac:spMkLst>
            <pc:docMk/>
            <pc:sldMk cId="1686707293" sldId="540"/>
            <ac:spMk id="10" creationId="{97CF14DF-48CD-4ECB-B1F0-7BF55B41314E}"/>
          </ac:spMkLst>
        </pc:spChg>
        <pc:picChg chg="del">
          <ac:chgData name="Roberto Merletti" userId="49473658533eb44f" providerId="LiveId" clId="{172C4C5D-A8F3-4134-AD16-791B771D8476}" dt="2022-04-24T21:51:12.405" v="3" actId="478"/>
          <ac:picMkLst>
            <pc:docMk/>
            <pc:sldMk cId="1686707293" sldId="540"/>
            <ac:picMk id="9" creationId="{D578ECF6-89B6-4E6B-8447-ED3254F465CD}"/>
          </ac:picMkLst>
        </pc:picChg>
      </pc:sldChg>
      <pc:sldChg chg="delSp modSp mod">
        <pc:chgData name="Roberto Merletti" userId="49473658533eb44f" providerId="LiveId" clId="{172C4C5D-A8F3-4134-AD16-791B771D8476}" dt="2022-04-24T21:51:22.333" v="6" actId="478"/>
        <pc:sldMkLst>
          <pc:docMk/>
          <pc:sldMk cId="2264215073" sldId="541"/>
        </pc:sldMkLst>
        <pc:spChg chg="del mod">
          <ac:chgData name="Roberto Merletti" userId="49473658533eb44f" providerId="LiveId" clId="{172C4C5D-A8F3-4134-AD16-791B771D8476}" dt="2022-04-24T21:51:19.500" v="5" actId="478"/>
          <ac:spMkLst>
            <pc:docMk/>
            <pc:sldMk cId="2264215073" sldId="541"/>
            <ac:spMk id="10" creationId="{FC7CD1B9-BDB3-48A4-A351-51F407F36A94}"/>
          </ac:spMkLst>
        </pc:spChg>
        <pc:picChg chg="del">
          <ac:chgData name="Roberto Merletti" userId="49473658533eb44f" providerId="LiveId" clId="{172C4C5D-A8F3-4134-AD16-791B771D8476}" dt="2022-04-24T21:51:22.333" v="6" actId="478"/>
          <ac:picMkLst>
            <pc:docMk/>
            <pc:sldMk cId="2264215073" sldId="541"/>
            <ac:picMk id="9" creationId="{31F949C6-FAA7-4C87-A3A9-40BF1B43E8E0}"/>
          </ac:picMkLst>
        </pc:picChg>
      </pc:sldChg>
      <pc:sldChg chg="delSp mod">
        <pc:chgData name="Roberto Merletti" userId="49473658533eb44f" providerId="LiveId" clId="{172C4C5D-A8F3-4134-AD16-791B771D8476}" dt="2022-04-24T21:51:30.484" v="8" actId="478"/>
        <pc:sldMkLst>
          <pc:docMk/>
          <pc:sldMk cId="2394133701" sldId="542"/>
        </pc:sldMkLst>
        <pc:spChg chg="del">
          <ac:chgData name="Roberto Merletti" userId="49473658533eb44f" providerId="LiveId" clId="{172C4C5D-A8F3-4134-AD16-791B771D8476}" dt="2022-04-24T21:51:28.188" v="7" actId="478"/>
          <ac:spMkLst>
            <pc:docMk/>
            <pc:sldMk cId="2394133701" sldId="542"/>
            <ac:spMk id="10" creationId="{42989409-4CD1-40A1-BB21-9C4DC08661E7}"/>
          </ac:spMkLst>
        </pc:spChg>
        <pc:picChg chg="del">
          <ac:chgData name="Roberto Merletti" userId="49473658533eb44f" providerId="LiveId" clId="{172C4C5D-A8F3-4134-AD16-791B771D8476}" dt="2022-04-24T21:51:30.484" v="8" actId="478"/>
          <ac:picMkLst>
            <pc:docMk/>
            <pc:sldMk cId="2394133701" sldId="542"/>
            <ac:picMk id="9" creationId="{205C2AD9-DABA-4333-ACC8-4A978FDE49AC}"/>
          </ac:picMkLst>
        </pc:picChg>
      </pc:sldChg>
      <pc:sldChg chg="delSp mod">
        <pc:chgData name="Roberto Merletti" userId="49473658533eb44f" providerId="LiveId" clId="{172C4C5D-A8F3-4134-AD16-791B771D8476}" dt="2022-04-24T21:51:41.162" v="10" actId="478"/>
        <pc:sldMkLst>
          <pc:docMk/>
          <pc:sldMk cId="1692689483" sldId="543"/>
        </pc:sldMkLst>
        <pc:spChg chg="del">
          <ac:chgData name="Roberto Merletti" userId="49473658533eb44f" providerId="LiveId" clId="{172C4C5D-A8F3-4134-AD16-791B771D8476}" dt="2022-04-24T21:51:37.813" v="9" actId="478"/>
          <ac:spMkLst>
            <pc:docMk/>
            <pc:sldMk cId="1692689483" sldId="543"/>
            <ac:spMk id="10" creationId="{7B46B728-BA2C-4219-BE3A-CAECC249DA89}"/>
          </ac:spMkLst>
        </pc:spChg>
        <pc:picChg chg="del">
          <ac:chgData name="Roberto Merletti" userId="49473658533eb44f" providerId="LiveId" clId="{172C4C5D-A8F3-4134-AD16-791B771D8476}" dt="2022-04-24T21:51:41.162" v="10" actId="478"/>
          <ac:picMkLst>
            <pc:docMk/>
            <pc:sldMk cId="1692689483" sldId="543"/>
            <ac:picMk id="9" creationId="{AD83817B-6279-4C6E-A78B-4E65C5DCD87E}"/>
          </ac:picMkLst>
        </pc:picChg>
      </pc:sldChg>
      <pc:sldChg chg="delSp modSp mod">
        <pc:chgData name="Roberto Merletti" userId="49473658533eb44f" providerId="LiveId" clId="{172C4C5D-A8F3-4134-AD16-791B771D8476}" dt="2022-04-24T21:51:54.117" v="14" actId="478"/>
        <pc:sldMkLst>
          <pc:docMk/>
          <pc:sldMk cId="1525583863" sldId="544"/>
        </pc:sldMkLst>
        <pc:spChg chg="del mod">
          <ac:chgData name="Roberto Merletti" userId="49473658533eb44f" providerId="LiveId" clId="{172C4C5D-A8F3-4134-AD16-791B771D8476}" dt="2022-04-24T21:51:48.545" v="13" actId="478"/>
          <ac:spMkLst>
            <pc:docMk/>
            <pc:sldMk cId="1525583863" sldId="544"/>
            <ac:spMk id="10" creationId="{8C87D8AE-3E46-4C4F-B6F0-896A299DB11A}"/>
          </ac:spMkLst>
        </pc:spChg>
        <pc:picChg chg="del">
          <ac:chgData name="Roberto Merletti" userId="49473658533eb44f" providerId="LiveId" clId="{172C4C5D-A8F3-4134-AD16-791B771D8476}" dt="2022-04-24T21:51:54.117" v="14" actId="478"/>
          <ac:picMkLst>
            <pc:docMk/>
            <pc:sldMk cId="1525583863" sldId="544"/>
            <ac:picMk id="9" creationId="{E067354D-E5A1-40EB-AC08-FFAA8DE63C42}"/>
          </ac:picMkLst>
        </pc:picChg>
      </pc:sldChg>
      <pc:sldMasterChg chg="modSldLayout">
        <pc:chgData name="Roberto Merletti" userId="49473658533eb44f" providerId="LiveId" clId="{172C4C5D-A8F3-4134-AD16-791B771D8476}" dt="2022-04-24T21:51:01.821" v="1" actId="478"/>
        <pc:sldMasterMkLst>
          <pc:docMk/>
          <pc:sldMasterMk cId="1344259150" sldId="2147483648"/>
        </pc:sldMasterMkLst>
        <pc:sldLayoutChg chg="delSp mod">
          <pc:chgData name="Roberto Merletti" userId="49473658533eb44f" providerId="LiveId" clId="{172C4C5D-A8F3-4134-AD16-791B771D8476}" dt="2022-04-24T21:51:01.821" v="1" actId="478"/>
          <pc:sldLayoutMkLst>
            <pc:docMk/>
            <pc:sldMasterMk cId="1344259150" sldId="2147483648"/>
            <pc:sldLayoutMk cId="3570687435" sldId="2147483660"/>
          </pc:sldLayoutMkLst>
          <pc:spChg chg="del">
            <ac:chgData name="Roberto Merletti" userId="49473658533eb44f" providerId="LiveId" clId="{172C4C5D-A8F3-4134-AD16-791B771D8476}" dt="2022-04-24T21:50:59.230" v="0" actId="478"/>
            <ac:spMkLst>
              <pc:docMk/>
              <pc:sldMasterMk cId="1344259150" sldId="2147483648"/>
              <pc:sldLayoutMk cId="3570687435" sldId="2147483660"/>
              <ac:spMk id="9" creationId="{00000000-0000-0000-0000-000000000000}"/>
            </ac:spMkLst>
          </pc:spChg>
          <pc:picChg chg="del">
            <ac:chgData name="Roberto Merletti" userId="49473658533eb44f" providerId="LiveId" clId="{172C4C5D-A8F3-4134-AD16-791B771D8476}" dt="2022-04-24T21:51:01.821" v="1" actId="478"/>
            <ac:picMkLst>
              <pc:docMk/>
              <pc:sldMasterMk cId="1344259150" sldId="2147483648"/>
              <pc:sldLayoutMk cId="3570687435" sldId="2147483660"/>
              <ac:picMk id="2" creationId="{00000000-0000-0000-0000-000000000000}"/>
            </ac:picMkLst>
          </pc:pic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5CB65-49C2-4BA6-81D5-446DF698D0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D5E134-DAFB-42E6-A7CF-AE4A086669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8D2373-F79C-49EC-B631-F998FAC5E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E3BBB8-2BEC-4077-8E9C-0A5C77DE0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BE83C2-9193-48CB-8591-B8357770C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081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50513-0AD7-410B-82AE-2039825C70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144CA8-9882-441D-AF06-A6C862384F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3524D4-43B7-4077-B458-5D24FFAE1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D24209-FF3F-46CB-917A-1AC1D4702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A3A9FC-E304-4790-8089-4790E891D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6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F94E91-A6B7-4865-86C1-B7BD806136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74B47E-664E-455F-BC49-C12E2B66AB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63F03B-F15A-434B-B8C4-219470C66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B818A3-09E9-4D87-9EB0-BFBD07D82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11F5D6-5EA5-4194-A639-B60EB32B1E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09389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L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>
                <a:latin typeface="+mn-lt"/>
              </a:defRPr>
            </a:lvl1pPr>
          </a:lstStyle>
          <a:p>
            <a:r>
              <a:rPr lang="en-US" dirty="0"/>
              <a:t>CC-BY-NC-ND Roberto Merletti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>
          <a:xfrm>
            <a:off x="8994058" y="6356352"/>
            <a:ext cx="2743200" cy="365125"/>
          </a:xfrm>
        </p:spPr>
        <p:txBody>
          <a:bodyPr/>
          <a:lstStyle/>
          <a:p>
            <a:fld id="{B363E4B2-0888-47DE-8A88-D22F6862BD51}" type="slidenum">
              <a:rPr lang="en-US" smtClean="0"/>
              <a:pPr/>
              <a:t>‹#›</a:t>
            </a:fld>
            <a:r>
              <a:rPr lang="en-US" dirty="0"/>
              <a:t> of 49</a:t>
            </a:r>
          </a:p>
        </p:txBody>
      </p:sp>
    </p:spTree>
    <p:extLst>
      <p:ext uri="{BB962C8B-B14F-4D97-AF65-F5344CB8AC3E}">
        <p14:creationId xmlns:p14="http://schemas.microsoft.com/office/powerpoint/2010/main" val="3570687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BF131-96FF-454F-98F1-3005710AB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7A0449-9CBC-4C91-8525-0BDB66E189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DF63E1-5A7C-447C-8988-C36B390DF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86E87-00C0-4626-95AF-B4F35DD8A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84EB61-2D91-4552-A5C7-02B7FE08D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9037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24146-2F76-4178-9521-2ACD9B3C6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5DB09F-1AE0-4469-9776-1BA0572725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5A885-F4D6-4C20-9890-E51863365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10E8EB-8BBA-42C6-9277-1D21A0D37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29F1D4-D351-4B54-9AE6-947CDCC6D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999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0239B6-709B-49E9-A8C0-547A445D7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18DD24-057D-4F2F-9A7B-B4C9033E0D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12094D-6A62-4326-A04E-A800196CB7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BDEA1D-455E-4CA2-927A-A62C051E1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186092-F39E-4BB5-B5B6-B72778451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992A09-6D35-45FC-B4D5-2CD7BF941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5664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CABAE-EED4-4A15-B802-5B368759D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093E1F-B8FB-4D04-BA76-5A6395152A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4C1A24-05B6-4B07-8D28-19DD9D32C3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DD117F-EEA5-445A-9B54-6B3BFD15B1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124ADAF-DAF5-44DB-90FB-91BB611E9E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C4997A-119F-4032-BCF3-E7218DE89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6C9F0A-FFE3-40CA-BAAA-C3792574E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767BFC-B39C-4E54-A220-36E0274DA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744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75C6D-DC1F-4B90-A442-A95365526E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D539037-BBF7-4965-97BF-1777617E6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AB294C-C748-43D2-8806-E13EAB404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B7241E-CDDE-490D-9FB5-87DE79A0E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547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9BA792E-3CEF-48F7-AE4B-E9F36C4C5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A394F7-5DF5-47AE-8167-7B0782243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0251DB-FDBA-4B7C-9BAA-34766B32B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1277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7C6CA-E43B-4515-9C1C-246DE5EE64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D7C010-71D5-4731-8BF6-7004DC8DEC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B5089-6751-43BE-803D-BCFEFE6AD4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5ABC98-5489-49C3-A63F-4A3B32603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17FDAD-D68B-461F-A0C0-4ECEA1205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DB0B4F-2DE4-407F-9C15-2AC56735A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71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4CC59-359D-4D00-9E6E-7ECD9240A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CBC65A-3395-42C0-95E3-E865E4D9B7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EAB7F2-B3ED-4510-97E2-A1873A8AA1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580CA6-7D36-45A7-BB3B-C282F50B1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E8515F-1D47-4143-978A-5F9082C41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59CDBF-CDF6-42D0-9C7A-1271D3F6D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740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8678A6-BC26-48D5-8C5D-4AB20A484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C95F89-952B-41F1-A0F4-7853AA8368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2BA793-3BD7-4E99-A82C-7F388BBA0E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93EF0-0F6A-444C-83A3-D23530A0767C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38B77-EFA2-4549-B174-2C0C92F06C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04F014-DDD4-44CA-8EDA-88ABDBC12C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4766-B830-477D-A223-0BF9B8B53A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259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416926" y="1140380"/>
            <a:ext cx="6874031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mulation of the effect of different conduction velocities on the action potential of a single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fiber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as detected on the skin by an electrode array in either monopolar or single differential configuration.</a:t>
            </a:r>
          </a:p>
          <a:p>
            <a:pPr algn="ctr"/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In this simulation signals are not normalized to highlight the change in amplitude as the conduction velocity changes.</a:t>
            </a:r>
          </a:p>
          <a:p>
            <a:pPr algn="ctr"/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uca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Mesin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Press repeatedly the backspace key, the arrow keys, or left click on mouse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0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48131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09538"/>
            <a:ext cx="12192000" cy="6967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13"/>
          <p:cNvSpPr txBox="1"/>
          <p:nvPr/>
        </p:nvSpPr>
        <p:spPr>
          <a:xfrm>
            <a:off x="9235188" y="2094762"/>
            <a:ext cx="1317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kin:   1mm</a:t>
            </a:r>
          </a:p>
        </p:txBody>
      </p:sp>
      <p:sp>
        <p:nvSpPr>
          <p:cNvPr id="5" name="TextBox 14"/>
          <p:cNvSpPr txBox="1"/>
          <p:nvPr/>
        </p:nvSpPr>
        <p:spPr>
          <a:xfrm>
            <a:off x="9058275" y="2473377"/>
            <a:ext cx="15838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Subcutaneous adipose tissue:  3mm</a:t>
            </a:r>
          </a:p>
        </p:txBody>
      </p:sp>
      <p:sp>
        <p:nvSpPr>
          <p:cNvPr id="6" name="TextBox 15"/>
          <p:cNvSpPr txBox="1"/>
          <p:nvPr/>
        </p:nvSpPr>
        <p:spPr>
          <a:xfrm>
            <a:off x="9880403" y="5446109"/>
            <a:ext cx="952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uscle</a:t>
            </a:r>
          </a:p>
        </p:txBody>
      </p:sp>
      <p:sp>
        <p:nvSpPr>
          <p:cNvPr id="7" name="TextBox 16"/>
          <p:cNvSpPr txBox="1"/>
          <p:nvPr/>
        </p:nvSpPr>
        <p:spPr>
          <a:xfrm>
            <a:off x="8865310" y="1203793"/>
            <a:ext cx="203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ectrode array</a:t>
            </a:r>
          </a:p>
        </p:txBody>
      </p:sp>
      <p:cxnSp>
        <p:nvCxnSpPr>
          <p:cNvPr id="8" name="Straight Arrow Connector 17"/>
          <p:cNvCxnSpPr/>
          <p:nvPr/>
        </p:nvCxnSpPr>
        <p:spPr>
          <a:xfrm>
            <a:off x="9745670" y="1549529"/>
            <a:ext cx="0" cy="53216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867072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4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49155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09538"/>
            <a:ext cx="12192000" cy="6967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13"/>
          <p:cNvSpPr txBox="1"/>
          <p:nvPr/>
        </p:nvSpPr>
        <p:spPr>
          <a:xfrm>
            <a:off x="9235188" y="2094762"/>
            <a:ext cx="1317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kin:   1mm</a:t>
            </a:r>
          </a:p>
        </p:txBody>
      </p:sp>
      <p:sp>
        <p:nvSpPr>
          <p:cNvPr id="5" name="TextBox 14"/>
          <p:cNvSpPr txBox="1"/>
          <p:nvPr/>
        </p:nvSpPr>
        <p:spPr>
          <a:xfrm>
            <a:off x="9058275" y="2473377"/>
            <a:ext cx="15838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Subcutaneous adipose tissue:  3mm</a:t>
            </a:r>
          </a:p>
        </p:txBody>
      </p:sp>
      <p:sp>
        <p:nvSpPr>
          <p:cNvPr id="6" name="TextBox 15"/>
          <p:cNvSpPr txBox="1"/>
          <p:nvPr/>
        </p:nvSpPr>
        <p:spPr>
          <a:xfrm>
            <a:off x="9880403" y="5446109"/>
            <a:ext cx="952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uscle</a:t>
            </a:r>
          </a:p>
        </p:txBody>
      </p:sp>
      <p:sp>
        <p:nvSpPr>
          <p:cNvPr id="7" name="TextBox 16"/>
          <p:cNvSpPr txBox="1"/>
          <p:nvPr/>
        </p:nvSpPr>
        <p:spPr>
          <a:xfrm>
            <a:off x="8865310" y="1203793"/>
            <a:ext cx="203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ectrode array</a:t>
            </a:r>
          </a:p>
        </p:txBody>
      </p:sp>
      <p:cxnSp>
        <p:nvCxnSpPr>
          <p:cNvPr id="8" name="Straight Arrow Connector 17"/>
          <p:cNvCxnSpPr/>
          <p:nvPr/>
        </p:nvCxnSpPr>
        <p:spPr>
          <a:xfrm>
            <a:off x="9745670" y="1549529"/>
            <a:ext cx="0" cy="53216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642150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8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50179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09538"/>
            <a:ext cx="12192000" cy="6967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13"/>
          <p:cNvSpPr txBox="1"/>
          <p:nvPr/>
        </p:nvSpPr>
        <p:spPr>
          <a:xfrm>
            <a:off x="9235188" y="2094762"/>
            <a:ext cx="1317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kin:   1mm</a:t>
            </a:r>
          </a:p>
        </p:txBody>
      </p:sp>
      <p:sp>
        <p:nvSpPr>
          <p:cNvPr id="5" name="TextBox 14"/>
          <p:cNvSpPr txBox="1"/>
          <p:nvPr/>
        </p:nvSpPr>
        <p:spPr>
          <a:xfrm>
            <a:off x="9058275" y="2473377"/>
            <a:ext cx="15838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Subcutaneous adipose tissue:  3mm</a:t>
            </a:r>
          </a:p>
        </p:txBody>
      </p:sp>
      <p:sp>
        <p:nvSpPr>
          <p:cNvPr id="6" name="TextBox 15"/>
          <p:cNvSpPr txBox="1"/>
          <p:nvPr/>
        </p:nvSpPr>
        <p:spPr>
          <a:xfrm>
            <a:off x="9880403" y="5446109"/>
            <a:ext cx="952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uscle</a:t>
            </a:r>
          </a:p>
        </p:txBody>
      </p:sp>
      <p:sp>
        <p:nvSpPr>
          <p:cNvPr id="7" name="TextBox 16"/>
          <p:cNvSpPr txBox="1"/>
          <p:nvPr/>
        </p:nvSpPr>
        <p:spPr>
          <a:xfrm>
            <a:off x="8865310" y="1203793"/>
            <a:ext cx="203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ectrode array</a:t>
            </a:r>
          </a:p>
        </p:txBody>
      </p:sp>
      <p:cxnSp>
        <p:nvCxnSpPr>
          <p:cNvPr id="8" name="Straight Arrow Connector 17"/>
          <p:cNvCxnSpPr/>
          <p:nvPr/>
        </p:nvCxnSpPr>
        <p:spPr>
          <a:xfrm>
            <a:off x="9745670" y="1549529"/>
            <a:ext cx="0" cy="53216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941337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51203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09538"/>
            <a:ext cx="12192000" cy="6967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13"/>
          <p:cNvSpPr txBox="1"/>
          <p:nvPr/>
        </p:nvSpPr>
        <p:spPr>
          <a:xfrm>
            <a:off x="9235188" y="2094762"/>
            <a:ext cx="1317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kin:   1mm</a:t>
            </a:r>
          </a:p>
        </p:txBody>
      </p:sp>
      <p:sp>
        <p:nvSpPr>
          <p:cNvPr id="5" name="TextBox 14"/>
          <p:cNvSpPr txBox="1"/>
          <p:nvPr/>
        </p:nvSpPr>
        <p:spPr>
          <a:xfrm>
            <a:off x="9058275" y="2473377"/>
            <a:ext cx="15838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Subcutaneous adipose tissue:  3mm</a:t>
            </a:r>
          </a:p>
        </p:txBody>
      </p:sp>
      <p:sp>
        <p:nvSpPr>
          <p:cNvPr id="6" name="TextBox 15"/>
          <p:cNvSpPr txBox="1"/>
          <p:nvPr/>
        </p:nvSpPr>
        <p:spPr>
          <a:xfrm>
            <a:off x="9880403" y="5446109"/>
            <a:ext cx="952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uscle</a:t>
            </a:r>
          </a:p>
        </p:txBody>
      </p:sp>
      <p:sp>
        <p:nvSpPr>
          <p:cNvPr id="7" name="TextBox 16"/>
          <p:cNvSpPr txBox="1"/>
          <p:nvPr/>
        </p:nvSpPr>
        <p:spPr>
          <a:xfrm>
            <a:off x="8865310" y="1203793"/>
            <a:ext cx="203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ectrode array</a:t>
            </a:r>
          </a:p>
        </p:txBody>
      </p:sp>
      <p:cxnSp>
        <p:nvCxnSpPr>
          <p:cNvPr id="8" name="Straight Arrow Connector 17"/>
          <p:cNvCxnSpPr/>
          <p:nvPr/>
        </p:nvCxnSpPr>
        <p:spPr>
          <a:xfrm>
            <a:off x="9745670" y="1549529"/>
            <a:ext cx="0" cy="53216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926894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26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52227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09538"/>
            <a:ext cx="12192000" cy="6967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13"/>
          <p:cNvSpPr txBox="1"/>
          <p:nvPr/>
        </p:nvSpPr>
        <p:spPr>
          <a:xfrm>
            <a:off x="9235188" y="2094762"/>
            <a:ext cx="1317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kin:   1mm</a:t>
            </a:r>
          </a:p>
        </p:txBody>
      </p:sp>
      <p:sp>
        <p:nvSpPr>
          <p:cNvPr id="5" name="TextBox 14"/>
          <p:cNvSpPr txBox="1"/>
          <p:nvPr/>
        </p:nvSpPr>
        <p:spPr>
          <a:xfrm>
            <a:off x="9058275" y="2473377"/>
            <a:ext cx="15838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Subcutaneous adipose tissue:  3mm</a:t>
            </a:r>
          </a:p>
        </p:txBody>
      </p:sp>
      <p:sp>
        <p:nvSpPr>
          <p:cNvPr id="6" name="TextBox 15"/>
          <p:cNvSpPr txBox="1"/>
          <p:nvPr/>
        </p:nvSpPr>
        <p:spPr>
          <a:xfrm>
            <a:off x="9880403" y="5446109"/>
            <a:ext cx="952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uscle</a:t>
            </a:r>
          </a:p>
        </p:txBody>
      </p:sp>
      <p:sp>
        <p:nvSpPr>
          <p:cNvPr id="7" name="TextBox 16"/>
          <p:cNvSpPr txBox="1"/>
          <p:nvPr/>
        </p:nvSpPr>
        <p:spPr>
          <a:xfrm>
            <a:off x="8865310" y="1203793"/>
            <a:ext cx="203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ectrode array</a:t>
            </a:r>
          </a:p>
        </p:txBody>
      </p:sp>
      <p:cxnSp>
        <p:nvCxnSpPr>
          <p:cNvPr id="8" name="Straight Arrow Connector 17"/>
          <p:cNvCxnSpPr/>
          <p:nvPr/>
        </p:nvCxnSpPr>
        <p:spPr>
          <a:xfrm>
            <a:off x="9745670" y="1549529"/>
            <a:ext cx="0" cy="53216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5583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Widescreen</PresentationFormat>
  <Paragraphs>2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Merletti</dc:creator>
  <cp:lastModifiedBy>Roberto Merletti</cp:lastModifiedBy>
  <cp:revision>1</cp:revision>
  <dcterms:created xsi:type="dcterms:W3CDTF">2022-03-09T18:50:41Z</dcterms:created>
  <dcterms:modified xsi:type="dcterms:W3CDTF">2022-04-24T21:51:59Z</dcterms:modified>
</cp:coreProperties>
</file>